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108" y="7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647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417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602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379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963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727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843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010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225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63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389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396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4584" y="2111531"/>
            <a:ext cx="5424232" cy="299558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990140" y="1765838"/>
            <a:ext cx="5965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    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   Normal control  (101)         Extra pulmonary (120)         Pulmonary only ( 106)</a:t>
            </a:r>
          </a:p>
        </p:txBody>
      </p:sp>
      <p:cxnSp>
        <p:nvCxnSpPr>
          <p:cNvPr id="8" name="Straight Connector 7"/>
          <p:cNvCxnSpPr/>
          <p:nvPr/>
        </p:nvCxnSpPr>
        <p:spPr>
          <a:xfrm>
            <a:off x="5086745" y="1737263"/>
            <a:ext cx="0" cy="39179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6953645" y="1765838"/>
            <a:ext cx="0" cy="39179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8620520" y="1765838"/>
            <a:ext cx="0" cy="39179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3523738" y="1765838"/>
            <a:ext cx="0" cy="39179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 rot="16200000">
            <a:off x="8357906" y="1871785"/>
            <a:ext cx="10395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ow      High</a:t>
            </a:r>
          </a:p>
        </p:txBody>
      </p:sp>
      <p:sp>
        <p:nvSpPr>
          <p:cNvPr id="13" name="Rectangle 12"/>
          <p:cNvSpPr/>
          <p:nvPr/>
        </p:nvSpPr>
        <p:spPr>
          <a:xfrm>
            <a:off x="542924" y="576251"/>
            <a:ext cx="1102042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 2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 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he </a:t>
            </a:r>
            <a:r>
              <a:rPr kumimoji="0" lang="en-US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atmap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of 120 IgM autoantigen shows reactivity expressed in terms of row z-score for a respective antigen across different patient samples. Each row in the graphics represent an antigen for serum specimens organized into columns classified as normal control (n = 101), extra pulmonary sarcoidosis (n = 120), and pulmonary only sarcoidosis (n = 106).  The reactivity intensity ranges from blue (low) to white (moderate) or red (high).  </a:t>
            </a:r>
          </a:p>
        </p:txBody>
      </p:sp>
    </p:spTree>
    <p:extLst>
      <p:ext uri="{BB962C8B-B14F-4D97-AF65-F5344CB8AC3E}">
        <p14:creationId xmlns:p14="http://schemas.microsoft.com/office/powerpoint/2010/main" val="232047727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mzeh, Nabeel Y</dc:creator>
  <cp:lastModifiedBy>Hamzeh, Nabeel Y</cp:lastModifiedBy>
  <cp:revision>1</cp:revision>
  <dcterms:created xsi:type="dcterms:W3CDTF">2022-09-27T14:05:35Z</dcterms:created>
  <dcterms:modified xsi:type="dcterms:W3CDTF">2022-09-27T14:05:53Z</dcterms:modified>
</cp:coreProperties>
</file>